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68" r:id="rId1"/>
  </p:sldMasterIdLst>
  <p:notesMasterIdLst>
    <p:notesMasterId r:id="rId3"/>
  </p:notesMasterIdLst>
  <p:sldIdLst>
    <p:sldId id="256" r:id="rId2"/>
  </p:sldIdLst>
  <p:sldSz cx="7380288" cy="11520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794" autoAdjust="0"/>
  </p:normalViewPr>
  <p:slideViewPr>
    <p:cSldViewPr snapToGrid="0">
      <p:cViewPr varScale="1">
        <p:scale>
          <a:sx n="33" d="100"/>
          <a:sy n="33" d="100"/>
        </p:scale>
        <p:origin x="23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557A8-9C08-4C62-8688-C4B8FA228821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1575" y="1143000"/>
            <a:ext cx="1974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BFB99E-A572-4C00-B2FE-B5BCF69B92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7272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31729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1pPr>
    <a:lvl2pPr marL="465864" algn="l" defTabSz="931729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2pPr>
    <a:lvl3pPr marL="931729" algn="l" defTabSz="931729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3pPr>
    <a:lvl4pPr marL="1397592" algn="l" defTabSz="931729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4pPr>
    <a:lvl5pPr marL="1863456" algn="l" defTabSz="931729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5pPr>
    <a:lvl6pPr marL="2329321" algn="l" defTabSz="931729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6pPr>
    <a:lvl7pPr marL="2795185" algn="l" defTabSz="931729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7pPr>
    <a:lvl8pPr marL="3261048" algn="l" defTabSz="931729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8pPr>
    <a:lvl9pPr marL="3726913" algn="l" defTabSz="931729" rtl="0" eaLnBrk="1" latinLnBrk="0" hangingPunct="1">
      <a:defRPr sz="122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441575" y="1143000"/>
            <a:ext cx="19748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BFB99E-A572-4C00-B2FE-B5BCF69B928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980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53522" y="1885414"/>
            <a:ext cx="6273245" cy="4010837"/>
          </a:xfrm>
        </p:spPr>
        <p:txBody>
          <a:bodyPr anchor="b"/>
          <a:lstStyle>
            <a:lvl1pPr algn="ctr">
              <a:defRPr sz="484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22536" y="6050924"/>
            <a:ext cx="5535216" cy="2781450"/>
          </a:xfrm>
        </p:spPr>
        <p:txBody>
          <a:bodyPr/>
          <a:lstStyle>
            <a:lvl1pPr marL="0" indent="0" algn="ctr">
              <a:buNone/>
              <a:defRPr sz="1937"/>
            </a:lvl1pPr>
            <a:lvl2pPr marL="369006" indent="0" algn="ctr">
              <a:buNone/>
              <a:defRPr sz="1614"/>
            </a:lvl2pPr>
            <a:lvl3pPr marL="738012" indent="0" algn="ctr">
              <a:buNone/>
              <a:defRPr sz="1453"/>
            </a:lvl3pPr>
            <a:lvl4pPr marL="1107018" indent="0" algn="ctr">
              <a:buNone/>
              <a:defRPr sz="1291"/>
            </a:lvl4pPr>
            <a:lvl5pPr marL="1476024" indent="0" algn="ctr">
              <a:buNone/>
              <a:defRPr sz="1291"/>
            </a:lvl5pPr>
            <a:lvl6pPr marL="1845031" indent="0" algn="ctr">
              <a:buNone/>
              <a:defRPr sz="1291"/>
            </a:lvl6pPr>
            <a:lvl7pPr marL="2214037" indent="0" algn="ctr">
              <a:buNone/>
              <a:defRPr sz="1291"/>
            </a:lvl7pPr>
            <a:lvl8pPr marL="2583043" indent="0" algn="ctr">
              <a:buNone/>
              <a:defRPr sz="1291"/>
            </a:lvl8pPr>
            <a:lvl9pPr marL="2952049" indent="0" algn="ctr">
              <a:buNone/>
              <a:defRPr sz="129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4743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1778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81519" y="613359"/>
            <a:ext cx="1591375" cy="9763081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7395" y="613359"/>
            <a:ext cx="4681870" cy="9763081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56524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7319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552" y="2872125"/>
            <a:ext cx="6365498" cy="4792202"/>
          </a:xfrm>
        </p:spPr>
        <p:txBody>
          <a:bodyPr anchor="b"/>
          <a:lstStyle>
            <a:lvl1pPr>
              <a:defRPr sz="484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552" y="7709663"/>
            <a:ext cx="6365498" cy="2520106"/>
          </a:xfrm>
        </p:spPr>
        <p:txBody>
          <a:bodyPr/>
          <a:lstStyle>
            <a:lvl1pPr marL="0" indent="0">
              <a:buNone/>
              <a:defRPr sz="1937">
                <a:solidFill>
                  <a:schemeClr val="tx1"/>
                </a:solidFill>
              </a:defRPr>
            </a:lvl1pPr>
            <a:lvl2pPr marL="369006" indent="0">
              <a:buNone/>
              <a:defRPr sz="1614">
                <a:solidFill>
                  <a:schemeClr val="tx1">
                    <a:tint val="75000"/>
                  </a:schemeClr>
                </a:solidFill>
              </a:defRPr>
            </a:lvl2pPr>
            <a:lvl3pPr marL="738012" indent="0">
              <a:buNone/>
              <a:defRPr sz="1453">
                <a:solidFill>
                  <a:schemeClr val="tx1">
                    <a:tint val="75000"/>
                  </a:schemeClr>
                </a:solidFill>
              </a:defRPr>
            </a:lvl3pPr>
            <a:lvl4pPr marL="1107018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4pPr>
            <a:lvl5pPr marL="1476024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5pPr>
            <a:lvl6pPr marL="1845031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6pPr>
            <a:lvl7pPr marL="2214037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7pPr>
            <a:lvl8pPr marL="2583043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8pPr>
            <a:lvl9pPr marL="2952049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66285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7395" y="3066796"/>
            <a:ext cx="3136622" cy="730964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36271" y="3066796"/>
            <a:ext cx="3136622" cy="730964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040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8356" y="613362"/>
            <a:ext cx="6365498" cy="222676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8357" y="2824120"/>
            <a:ext cx="3122207" cy="1384058"/>
          </a:xfrm>
        </p:spPr>
        <p:txBody>
          <a:bodyPr anchor="b"/>
          <a:lstStyle>
            <a:lvl1pPr marL="0" indent="0">
              <a:buNone/>
              <a:defRPr sz="1937" b="1"/>
            </a:lvl1pPr>
            <a:lvl2pPr marL="369006" indent="0">
              <a:buNone/>
              <a:defRPr sz="1614" b="1"/>
            </a:lvl2pPr>
            <a:lvl3pPr marL="738012" indent="0">
              <a:buNone/>
              <a:defRPr sz="1453" b="1"/>
            </a:lvl3pPr>
            <a:lvl4pPr marL="1107018" indent="0">
              <a:buNone/>
              <a:defRPr sz="1291" b="1"/>
            </a:lvl4pPr>
            <a:lvl5pPr marL="1476024" indent="0">
              <a:buNone/>
              <a:defRPr sz="1291" b="1"/>
            </a:lvl5pPr>
            <a:lvl6pPr marL="1845031" indent="0">
              <a:buNone/>
              <a:defRPr sz="1291" b="1"/>
            </a:lvl6pPr>
            <a:lvl7pPr marL="2214037" indent="0">
              <a:buNone/>
              <a:defRPr sz="1291" b="1"/>
            </a:lvl7pPr>
            <a:lvl8pPr marL="2583043" indent="0">
              <a:buNone/>
              <a:defRPr sz="1291" b="1"/>
            </a:lvl8pPr>
            <a:lvl9pPr marL="2952049" indent="0">
              <a:buNone/>
              <a:defRPr sz="129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8357" y="4208178"/>
            <a:ext cx="3122207" cy="618959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36271" y="2824120"/>
            <a:ext cx="3137584" cy="1384058"/>
          </a:xfrm>
        </p:spPr>
        <p:txBody>
          <a:bodyPr anchor="b"/>
          <a:lstStyle>
            <a:lvl1pPr marL="0" indent="0">
              <a:buNone/>
              <a:defRPr sz="1937" b="1"/>
            </a:lvl1pPr>
            <a:lvl2pPr marL="369006" indent="0">
              <a:buNone/>
              <a:defRPr sz="1614" b="1"/>
            </a:lvl2pPr>
            <a:lvl3pPr marL="738012" indent="0">
              <a:buNone/>
              <a:defRPr sz="1453" b="1"/>
            </a:lvl3pPr>
            <a:lvl4pPr marL="1107018" indent="0">
              <a:buNone/>
              <a:defRPr sz="1291" b="1"/>
            </a:lvl4pPr>
            <a:lvl5pPr marL="1476024" indent="0">
              <a:buNone/>
              <a:defRPr sz="1291" b="1"/>
            </a:lvl5pPr>
            <a:lvl6pPr marL="1845031" indent="0">
              <a:buNone/>
              <a:defRPr sz="1291" b="1"/>
            </a:lvl6pPr>
            <a:lvl7pPr marL="2214037" indent="0">
              <a:buNone/>
              <a:defRPr sz="1291" b="1"/>
            </a:lvl7pPr>
            <a:lvl8pPr marL="2583043" indent="0">
              <a:buNone/>
              <a:defRPr sz="1291" b="1"/>
            </a:lvl8pPr>
            <a:lvl9pPr marL="2952049" indent="0">
              <a:buNone/>
              <a:defRPr sz="129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36271" y="4208178"/>
            <a:ext cx="3137584" cy="618959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5915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8312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776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8356" y="768032"/>
            <a:ext cx="2380335" cy="2688114"/>
          </a:xfrm>
        </p:spPr>
        <p:txBody>
          <a:bodyPr anchor="b"/>
          <a:lstStyle>
            <a:lvl1pPr>
              <a:defRPr sz="258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37584" y="1658740"/>
            <a:ext cx="3736271" cy="8187013"/>
          </a:xfrm>
        </p:spPr>
        <p:txBody>
          <a:bodyPr/>
          <a:lstStyle>
            <a:lvl1pPr>
              <a:defRPr sz="2583"/>
            </a:lvl1pPr>
            <a:lvl2pPr>
              <a:defRPr sz="2260"/>
            </a:lvl2pPr>
            <a:lvl3pPr>
              <a:defRPr sz="1937"/>
            </a:lvl3pPr>
            <a:lvl4pPr>
              <a:defRPr sz="1614"/>
            </a:lvl4pPr>
            <a:lvl5pPr>
              <a:defRPr sz="1614"/>
            </a:lvl5pPr>
            <a:lvl6pPr>
              <a:defRPr sz="1614"/>
            </a:lvl6pPr>
            <a:lvl7pPr>
              <a:defRPr sz="1614"/>
            </a:lvl7pPr>
            <a:lvl8pPr>
              <a:defRPr sz="1614"/>
            </a:lvl8pPr>
            <a:lvl9pPr>
              <a:defRPr sz="1614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8356" y="3456146"/>
            <a:ext cx="2380335" cy="6402939"/>
          </a:xfrm>
        </p:spPr>
        <p:txBody>
          <a:bodyPr/>
          <a:lstStyle>
            <a:lvl1pPr marL="0" indent="0">
              <a:buNone/>
              <a:defRPr sz="1291"/>
            </a:lvl1pPr>
            <a:lvl2pPr marL="369006" indent="0">
              <a:buNone/>
              <a:defRPr sz="1130"/>
            </a:lvl2pPr>
            <a:lvl3pPr marL="738012" indent="0">
              <a:buNone/>
              <a:defRPr sz="969"/>
            </a:lvl3pPr>
            <a:lvl4pPr marL="1107018" indent="0">
              <a:buNone/>
              <a:defRPr sz="807"/>
            </a:lvl4pPr>
            <a:lvl5pPr marL="1476024" indent="0">
              <a:buNone/>
              <a:defRPr sz="807"/>
            </a:lvl5pPr>
            <a:lvl6pPr marL="1845031" indent="0">
              <a:buNone/>
              <a:defRPr sz="807"/>
            </a:lvl6pPr>
            <a:lvl7pPr marL="2214037" indent="0">
              <a:buNone/>
              <a:defRPr sz="807"/>
            </a:lvl7pPr>
            <a:lvl8pPr marL="2583043" indent="0">
              <a:buNone/>
              <a:defRPr sz="807"/>
            </a:lvl8pPr>
            <a:lvl9pPr marL="2952049" indent="0">
              <a:buNone/>
              <a:defRPr sz="80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55503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8356" y="768032"/>
            <a:ext cx="2380335" cy="2688114"/>
          </a:xfrm>
        </p:spPr>
        <p:txBody>
          <a:bodyPr anchor="b"/>
          <a:lstStyle>
            <a:lvl1pPr>
              <a:defRPr sz="258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37584" y="1658740"/>
            <a:ext cx="3736271" cy="8187013"/>
          </a:xfrm>
        </p:spPr>
        <p:txBody>
          <a:bodyPr anchor="t"/>
          <a:lstStyle>
            <a:lvl1pPr marL="0" indent="0">
              <a:buNone/>
              <a:defRPr sz="2583"/>
            </a:lvl1pPr>
            <a:lvl2pPr marL="369006" indent="0">
              <a:buNone/>
              <a:defRPr sz="2260"/>
            </a:lvl2pPr>
            <a:lvl3pPr marL="738012" indent="0">
              <a:buNone/>
              <a:defRPr sz="1937"/>
            </a:lvl3pPr>
            <a:lvl4pPr marL="1107018" indent="0">
              <a:buNone/>
              <a:defRPr sz="1614"/>
            </a:lvl4pPr>
            <a:lvl5pPr marL="1476024" indent="0">
              <a:buNone/>
              <a:defRPr sz="1614"/>
            </a:lvl5pPr>
            <a:lvl6pPr marL="1845031" indent="0">
              <a:buNone/>
              <a:defRPr sz="1614"/>
            </a:lvl6pPr>
            <a:lvl7pPr marL="2214037" indent="0">
              <a:buNone/>
              <a:defRPr sz="1614"/>
            </a:lvl7pPr>
            <a:lvl8pPr marL="2583043" indent="0">
              <a:buNone/>
              <a:defRPr sz="1614"/>
            </a:lvl8pPr>
            <a:lvl9pPr marL="2952049" indent="0">
              <a:buNone/>
              <a:defRPr sz="161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8356" y="3456146"/>
            <a:ext cx="2380335" cy="6402939"/>
          </a:xfrm>
        </p:spPr>
        <p:txBody>
          <a:bodyPr/>
          <a:lstStyle>
            <a:lvl1pPr marL="0" indent="0">
              <a:buNone/>
              <a:defRPr sz="1291"/>
            </a:lvl1pPr>
            <a:lvl2pPr marL="369006" indent="0">
              <a:buNone/>
              <a:defRPr sz="1130"/>
            </a:lvl2pPr>
            <a:lvl3pPr marL="738012" indent="0">
              <a:buNone/>
              <a:defRPr sz="969"/>
            </a:lvl3pPr>
            <a:lvl4pPr marL="1107018" indent="0">
              <a:buNone/>
              <a:defRPr sz="807"/>
            </a:lvl4pPr>
            <a:lvl5pPr marL="1476024" indent="0">
              <a:buNone/>
              <a:defRPr sz="807"/>
            </a:lvl5pPr>
            <a:lvl6pPr marL="1845031" indent="0">
              <a:buNone/>
              <a:defRPr sz="807"/>
            </a:lvl6pPr>
            <a:lvl7pPr marL="2214037" indent="0">
              <a:buNone/>
              <a:defRPr sz="807"/>
            </a:lvl7pPr>
            <a:lvl8pPr marL="2583043" indent="0">
              <a:buNone/>
              <a:defRPr sz="807"/>
            </a:lvl8pPr>
            <a:lvl9pPr marL="2952049" indent="0">
              <a:buNone/>
              <a:defRPr sz="80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86891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7395" y="613362"/>
            <a:ext cx="6365498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7395" y="3066796"/>
            <a:ext cx="6365498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7395" y="10677788"/>
            <a:ext cx="1660565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BE5D3-88AA-472C-8759-54A64E04400C}" type="datetimeFigureOut">
              <a:rPr lang="zh-CN" altLang="en-US" smtClean="0"/>
              <a:t>2021/10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44721" y="10677788"/>
            <a:ext cx="2490847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212328" y="10677788"/>
            <a:ext cx="1660565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8607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69" r:id="rId1"/>
    <p:sldLayoutId id="2147483770" r:id="rId2"/>
    <p:sldLayoutId id="2147483771" r:id="rId3"/>
    <p:sldLayoutId id="2147483772" r:id="rId4"/>
    <p:sldLayoutId id="2147483773" r:id="rId5"/>
    <p:sldLayoutId id="2147483774" r:id="rId6"/>
    <p:sldLayoutId id="2147483775" r:id="rId7"/>
    <p:sldLayoutId id="2147483776" r:id="rId8"/>
    <p:sldLayoutId id="2147483777" r:id="rId9"/>
    <p:sldLayoutId id="2147483778" r:id="rId10"/>
    <p:sldLayoutId id="2147483779" r:id="rId11"/>
  </p:sldLayoutIdLst>
  <p:txStyles>
    <p:titleStyle>
      <a:lvl1pPr algn="l" defTabSz="738012" rtl="0" eaLnBrk="1" latinLnBrk="0" hangingPunct="1">
        <a:lnSpc>
          <a:spcPct val="90000"/>
        </a:lnSpc>
        <a:spcBef>
          <a:spcPct val="0"/>
        </a:spcBef>
        <a:buNone/>
        <a:defRPr sz="355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4503" indent="-184503" algn="l" defTabSz="738012" rtl="0" eaLnBrk="1" latinLnBrk="0" hangingPunct="1">
        <a:lnSpc>
          <a:spcPct val="90000"/>
        </a:lnSpc>
        <a:spcBef>
          <a:spcPts val="807"/>
        </a:spcBef>
        <a:buFont typeface="Arial" panose="020B0604020202020204" pitchFamily="34" charset="0"/>
        <a:buChar char="•"/>
        <a:defRPr sz="2260" kern="1200">
          <a:solidFill>
            <a:schemeClr val="tx1"/>
          </a:solidFill>
          <a:latin typeface="+mn-lt"/>
          <a:ea typeface="+mn-ea"/>
          <a:cs typeface="+mn-cs"/>
        </a:defRPr>
      </a:lvl1pPr>
      <a:lvl2pPr marL="553509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937" kern="1200">
          <a:solidFill>
            <a:schemeClr val="tx1"/>
          </a:solidFill>
          <a:latin typeface="+mn-lt"/>
          <a:ea typeface="+mn-ea"/>
          <a:cs typeface="+mn-cs"/>
        </a:defRPr>
      </a:lvl2pPr>
      <a:lvl3pPr marL="922515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614" kern="1200">
          <a:solidFill>
            <a:schemeClr val="tx1"/>
          </a:solidFill>
          <a:latin typeface="+mn-lt"/>
          <a:ea typeface="+mn-ea"/>
          <a:cs typeface="+mn-cs"/>
        </a:defRPr>
      </a:lvl3pPr>
      <a:lvl4pPr marL="1291521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4pPr>
      <a:lvl5pPr marL="1660528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5pPr>
      <a:lvl6pPr marL="2029534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6pPr>
      <a:lvl7pPr marL="2398540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7pPr>
      <a:lvl8pPr marL="2767546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8pPr>
      <a:lvl9pPr marL="3136552" indent="-184503" algn="l" defTabSz="738012" rtl="0" eaLnBrk="1" latinLnBrk="0" hangingPunct="1">
        <a:lnSpc>
          <a:spcPct val="90000"/>
        </a:lnSpc>
        <a:spcBef>
          <a:spcPts val="404"/>
        </a:spcBef>
        <a:buFont typeface="Arial" panose="020B0604020202020204" pitchFamily="34" charset="0"/>
        <a:buChar char="•"/>
        <a:defRPr sz="145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1pPr>
      <a:lvl2pPr marL="369006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2pPr>
      <a:lvl3pPr marL="738012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3pPr>
      <a:lvl4pPr marL="1107018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4pPr>
      <a:lvl5pPr marL="1476024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5pPr>
      <a:lvl6pPr marL="1845031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6pPr>
      <a:lvl7pPr marL="2214037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7pPr>
      <a:lvl8pPr marL="2583043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8pPr>
      <a:lvl9pPr marL="2952049" algn="l" defTabSz="738012" rtl="0" eaLnBrk="1" latinLnBrk="0" hangingPunct="1">
        <a:defRPr sz="145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Picture 17">
            <a:extLst>
              <a:ext uri="{FF2B5EF4-FFF2-40B4-BE49-F238E27FC236}">
                <a16:creationId xmlns:a16="http://schemas.microsoft.com/office/drawing/2014/main" id="{F60C75C2-DA7A-4688-BA97-257621EE25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154184" y="5857394"/>
            <a:ext cx="2821882" cy="2796805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FBAE9252-3F82-49E0-8B81-D5D8D1EBE7E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122186" y="5903232"/>
            <a:ext cx="2775633" cy="2750967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371D95CE-2BBE-4BDF-BFB3-82CCB4C7BFA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123704" y="3146129"/>
            <a:ext cx="2852362" cy="279434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96BBC227-4501-47CA-82AF-ECEDF3FA377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60698" y="3170718"/>
            <a:ext cx="2852361" cy="2794339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56BA9644-109E-4089-9416-12D907976C1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109526" y="336829"/>
            <a:ext cx="2866541" cy="2819962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D8FAF055-4E04-4256-83FA-8B6E41DE990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060698" y="388151"/>
            <a:ext cx="2837125" cy="2791024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172C68C6-477A-4135-AECD-8635291871E1}"/>
              </a:ext>
            </a:extLst>
          </p:cNvPr>
          <p:cNvSpPr txBox="1"/>
          <p:nvPr/>
        </p:nvSpPr>
        <p:spPr>
          <a:xfrm>
            <a:off x="743695" y="321888"/>
            <a:ext cx="317003" cy="3211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87" b="1" dirty="0"/>
              <a:t>A</a:t>
            </a:r>
            <a:endParaRPr lang="zh-CN" altLang="en-US" sz="1487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20FB525-33EC-453B-B5C0-415B0AB6F0D5}"/>
              </a:ext>
            </a:extLst>
          </p:cNvPr>
          <p:cNvSpPr txBox="1"/>
          <p:nvPr/>
        </p:nvSpPr>
        <p:spPr>
          <a:xfrm>
            <a:off x="3951025" y="336969"/>
            <a:ext cx="317003" cy="3211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87" b="1" dirty="0"/>
              <a:t>B</a:t>
            </a:r>
            <a:endParaRPr lang="zh-CN" altLang="en-US" sz="1487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F9AC3D2-E470-42B6-A2F8-AA745A08A95D}"/>
              </a:ext>
            </a:extLst>
          </p:cNvPr>
          <p:cNvSpPr txBox="1"/>
          <p:nvPr/>
        </p:nvSpPr>
        <p:spPr>
          <a:xfrm>
            <a:off x="789577" y="3158662"/>
            <a:ext cx="474307" cy="3211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87" b="1" dirty="0"/>
              <a:t>C</a:t>
            </a:r>
            <a:endParaRPr lang="zh-CN" altLang="en-US" sz="1487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FD4A4B1-9885-48B2-A912-E1EB80A291F2}"/>
              </a:ext>
            </a:extLst>
          </p:cNvPr>
          <p:cNvSpPr txBox="1"/>
          <p:nvPr/>
        </p:nvSpPr>
        <p:spPr>
          <a:xfrm>
            <a:off x="3951025" y="3196391"/>
            <a:ext cx="317003" cy="3211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87" b="1" dirty="0"/>
              <a:t>D</a:t>
            </a:r>
            <a:endParaRPr lang="zh-CN" altLang="en-US" sz="1487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6C82D28-45C8-41E5-87A6-1B37FD256CBF}"/>
              </a:ext>
            </a:extLst>
          </p:cNvPr>
          <p:cNvSpPr txBox="1"/>
          <p:nvPr/>
        </p:nvSpPr>
        <p:spPr>
          <a:xfrm>
            <a:off x="870395" y="5902901"/>
            <a:ext cx="311275" cy="328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87" b="1" dirty="0"/>
              <a:t>E</a:t>
            </a:r>
            <a:endParaRPr lang="zh-CN" altLang="en-US" sz="1487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A2CD887-B5B9-4397-9182-FCF3CC7C33E1}"/>
              </a:ext>
            </a:extLst>
          </p:cNvPr>
          <p:cNvSpPr txBox="1"/>
          <p:nvPr/>
        </p:nvSpPr>
        <p:spPr>
          <a:xfrm>
            <a:off x="3995686" y="5940465"/>
            <a:ext cx="317003" cy="3211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87" b="1" dirty="0"/>
              <a:t>F</a:t>
            </a:r>
            <a:endParaRPr lang="zh-CN" altLang="en-US" sz="1487" b="1" dirty="0"/>
          </a:p>
        </p:txBody>
      </p:sp>
      <p:sp>
        <p:nvSpPr>
          <p:cNvPr id="30" name="文本框 15">
            <a:extLst>
              <a:ext uri="{FF2B5EF4-FFF2-40B4-BE49-F238E27FC236}">
                <a16:creationId xmlns:a16="http://schemas.microsoft.com/office/drawing/2014/main" id="{20ABF206-2F03-4AEA-A313-6A3741EEEF2E}"/>
              </a:ext>
            </a:extLst>
          </p:cNvPr>
          <p:cNvSpPr txBox="1"/>
          <p:nvPr/>
        </p:nvSpPr>
        <p:spPr>
          <a:xfrm>
            <a:off x="317747" y="9032692"/>
            <a:ext cx="6827035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Figure S8.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acterial species markers for pairwise discriminations of </a:t>
            </a:r>
            <a:r>
              <a:rPr lang="en-US" altLang="zh-CN" sz="14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RC, CRA and NC groups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r>
              <a:rPr lang="en-US" altLang="zh-CN" sz="14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A)</a:t>
            </a:r>
            <a:r>
              <a:rPr lang="en-US" altLang="zh-CN" sz="14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eceiver operating characteristic (ROC) analysis applying the 6 CRC vs NC bacteria markers to discriminate CRC from CRA. </a:t>
            </a:r>
            <a:r>
              <a:rPr lang="en-US" altLang="zh-CN" sz="14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B)</a:t>
            </a:r>
            <a:r>
              <a:rPr lang="en-US" altLang="zh-CN" sz="14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applying the 6 CRC vs NC bacteria markers to discriminate CRA from NC.</a:t>
            </a:r>
            <a:r>
              <a:rPr lang="en-US" altLang="zh-CN" sz="14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C)</a:t>
            </a:r>
            <a:r>
              <a:rPr lang="en-US" altLang="zh-CN" sz="14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applying the 14 CRA vs NC bacteria markers to discriminate CRC from NC. </a:t>
            </a:r>
            <a:r>
              <a:rPr lang="en-US" altLang="zh-CN" sz="14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D)</a:t>
            </a:r>
            <a:r>
              <a:rPr lang="en-US" altLang="zh-CN" sz="14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applying the 14 CRA vs NC bacteria markers to discriminate CRC from CRA.</a:t>
            </a:r>
            <a:r>
              <a:rPr lang="en-US" altLang="zh-CN" sz="14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(E)</a:t>
            </a:r>
            <a:r>
              <a:rPr lang="en-US" altLang="zh-CN" sz="14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applying the 6 CRC vs CRA bacteria markers to discriminate CRC from NC. </a:t>
            </a:r>
            <a:r>
              <a:rPr lang="en-US" altLang="zh-CN" sz="140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F)</a:t>
            </a:r>
            <a:r>
              <a:rPr lang="en-US" altLang="zh-CN" sz="14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srgbClr val="000000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OC analysis applying the 6 CRC vs CRA bacteria markers to discriminate CRA from NC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14">
            <a:extLst>
              <a:ext uri="{FF2B5EF4-FFF2-40B4-BE49-F238E27FC236}">
                <a16:creationId xmlns:a16="http://schemas.microsoft.com/office/drawing/2014/main" id="{8B6486DA-7E5A-462B-87B3-D9E65DD2F047}"/>
              </a:ext>
            </a:extLst>
          </p:cNvPr>
          <p:cNvSpPr txBox="1"/>
          <p:nvPr/>
        </p:nvSpPr>
        <p:spPr>
          <a:xfrm>
            <a:off x="2330338" y="8588394"/>
            <a:ext cx="3609515" cy="385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False Positive Percentage (%)</a:t>
            </a:r>
            <a:endParaRPr lang="zh-CN" altLang="en-US" b="1" dirty="0"/>
          </a:p>
        </p:txBody>
      </p:sp>
      <p:sp>
        <p:nvSpPr>
          <p:cNvPr id="32" name="文本框 16">
            <a:extLst>
              <a:ext uri="{FF2B5EF4-FFF2-40B4-BE49-F238E27FC236}">
                <a16:creationId xmlns:a16="http://schemas.microsoft.com/office/drawing/2014/main" id="{74999BF4-C3DC-40C2-8E39-C1D145213BAD}"/>
              </a:ext>
            </a:extLst>
          </p:cNvPr>
          <p:cNvSpPr txBox="1"/>
          <p:nvPr/>
        </p:nvSpPr>
        <p:spPr>
          <a:xfrm rot="16200000">
            <a:off x="-1294265" y="4645135"/>
            <a:ext cx="3609515" cy="385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/>
              <a:t>True Positive Percentage (%)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97270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2</TotalTime>
  <Words>151</Words>
  <Application>Microsoft Office PowerPoint</Application>
  <PresentationFormat>Custom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an Liu</dc:creator>
  <cp:lastModifiedBy>Jun Yu (MEDT)</cp:lastModifiedBy>
  <cp:revision>56</cp:revision>
  <dcterms:created xsi:type="dcterms:W3CDTF">2020-10-05T01:00:00Z</dcterms:created>
  <dcterms:modified xsi:type="dcterms:W3CDTF">2021-10-21T15:21:09Z</dcterms:modified>
</cp:coreProperties>
</file>